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77" r:id="rId3"/>
    <p:sldId id="285" r:id="rId4"/>
  </p:sldIdLst>
  <p:sldSz cx="12192000" cy="6858000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43" d="100"/>
          <a:sy n="143" d="100"/>
        </p:scale>
        <p:origin x="150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5A12180-4E57-4AF9-A77C-5BAF5E5A0F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6392ABA9-1BAA-4322-9966-F750A6A851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46929E8-6845-4F4D-874D-73C38AED9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119E691-A194-4120-A448-AB10CFE28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EAAFEAB-E0E7-4335-A037-3D1405E682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8353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91CC636-C733-4D66-B7F6-0F349BBAC6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2ABB7F-FD89-4AC9-95DE-3B660064C3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5F9454B-91F0-41A1-9BD7-58D5308F0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CB549DF-EB31-44E7-89EF-84D9042FC4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8012E35-B262-48A3-9AAB-3FA57A090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7949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9B74943-70B7-4E91-B2FB-8C7A6C659A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FA1A9B7-8F68-4392-AA3E-6153DB5956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D97BB39-5306-4297-AA15-195A1F783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7A1EC1B-2A4C-43E8-BAC4-0C4D6BD92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085BB79-97F8-4F75-9717-C547813D8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5934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BCCB048-8393-4F7C-8E53-C1111B20F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FAACA4C-1785-4326-9AB1-52237F20F1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3F61A98-C938-41F9-BEB4-CC96096DE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9CEBA80-6EB5-49B4-A299-70D7ACB7C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808F404-0589-48C4-9E58-689684345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6024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DEA5903-87E0-4A27-B768-6D1937BE5D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A98F1F6-C3D3-4DF6-A541-798214A3D8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CD9B1A1-4DB1-4279-BACC-699771041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1FBE843-E033-4213-9D89-6BEE6A752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8BFAF49-B65A-4794-AF30-87C3758D42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9146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A83E0CC-D042-4875-9746-EE3FA9C06B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2199BD5-197C-47BA-9F73-448A46E717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ED75AF5-AAF9-42D6-AD18-9A73B326CB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70572E1-D710-4DF7-835E-72DD15848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CD8B162-BDBB-4B3B-82D8-005ACA372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7996AB7-58DD-46D0-9274-CA5EB61252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5851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AC39A6-AC12-4023-BA88-225B5BDB3E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367A201-A64A-4FCC-A883-D3AC6403AC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10F2A9B-418E-4536-A961-A17506AB2B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E132699-7AB5-4FE3-832C-2EE2B438E6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A919504-B025-4932-A3E1-FB252DD38E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0D02D89-44F9-4AE6-B7C7-56ECFB3BF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1E133CA-06E9-414E-A012-575B81ACA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B055FBBE-A01B-4F7A-9732-056C43CAD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5420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45EB75A-E2AB-463E-AA2A-5B4384B1CC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313CE8D2-A3CF-4089-876A-8634C687C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513363C4-657A-43A7-8647-07C6CAF45F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37A6D2EE-DBC4-4D07-80DD-BF5D3C6A1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9444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3553399-92D1-4606-9F3C-C6187CE7A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902F28F-83D6-4B8E-8673-71F2D3FA4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F14BD93-C19D-41FC-81ED-1BA5F68CE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0278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8383078-8523-42E2-A390-4D609D551C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06ED28B-ED0E-4B58-8A37-6901D4CD53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24C4A97-877A-4CE8-AEB5-FEABDCCC0B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D5D218B-201D-447D-9583-3954DA5AB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0B56A9D-4D41-4E61-87A9-970558014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9BBB278-CEB5-486B-8634-52055E01E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4057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AD42073-015E-4D71-9FDE-D36A43348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C091042-A912-433B-B586-D954D4BD2D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219CA23-0BC8-4F6D-9EB9-A9057E7555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E0F0E28-18A4-49E3-B096-8D0A5B31E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02CEABD-01A7-496E-BFFD-54B69C208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90641A9-FAD7-4A08-98D6-672864099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8738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72D5268E-B805-45BB-9971-4B68524BEE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DA0AF22-DF1A-43B7-BFB9-1C4F8E9BD2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C2D553E-AD0B-4EE3-9686-C1FD0B67BD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BBA76-8CFC-445A-B0D0-98F29DA5146B}" type="datetimeFigureOut">
              <a:rPr lang="ko-KR" altLang="en-US" smtClean="0"/>
              <a:t>2023-09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A70DD84-9DAA-44B0-9953-ADE42CE3EE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8CD0D70-81EB-42CA-861E-E6E2165627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8159F5-AD88-4396-B404-43652D285A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53296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>
            <a:extLst>
              <a:ext uri="{FF2B5EF4-FFF2-40B4-BE49-F238E27FC236}">
                <a16:creationId xmlns:a16="http://schemas.microsoft.com/office/drawing/2014/main" id="{2D76CB85-FC2E-4075-A7EE-08B54B30478C}"/>
              </a:ext>
            </a:extLst>
          </p:cNvPr>
          <p:cNvGrpSpPr/>
          <p:nvPr/>
        </p:nvGrpSpPr>
        <p:grpSpPr>
          <a:xfrm>
            <a:off x="2192338" y="2557463"/>
            <a:ext cx="7862887" cy="1712912"/>
            <a:chOff x="2888529" y="2386006"/>
            <a:chExt cx="7862887" cy="1712912"/>
          </a:xfrm>
        </p:grpSpPr>
        <p:graphicFrame>
          <p:nvGraphicFramePr>
            <p:cNvPr id="2" name="개체 1">
              <a:extLst>
                <a:ext uri="{FF2B5EF4-FFF2-40B4-BE49-F238E27FC236}">
                  <a16:creationId xmlns:a16="http://schemas.microsoft.com/office/drawing/2014/main" id="{B7A77B92-FC8E-4541-AF9A-4E69464A9BA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88176691"/>
                </p:ext>
              </p:extLst>
            </p:nvPr>
          </p:nvGraphicFramePr>
          <p:xfrm>
            <a:off x="2888529" y="2419343"/>
            <a:ext cx="2314575" cy="16764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5" name="Prism 10" r:id="rId3" imgW="3727765" imgH="2706197" progId="Prism10.Document">
                    <p:embed/>
                  </p:oleObj>
                </mc:Choice>
                <mc:Fallback>
                  <p:oleObj name="Prism 10" r:id="rId3" imgW="3727765" imgH="2706197" progId="Prism10.Document">
                    <p:embed/>
                    <p:pic>
                      <p:nvPicPr>
                        <p:cNvPr id="2" name="개체 1">
                          <a:extLst>
                            <a:ext uri="{FF2B5EF4-FFF2-40B4-BE49-F238E27FC236}">
                              <a16:creationId xmlns:a16="http://schemas.microsoft.com/office/drawing/2014/main" id="{B7A77B92-FC8E-4541-AF9A-4E69464A9BA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888529" y="2419343"/>
                          <a:ext cx="2314575" cy="16764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개체 2">
              <a:extLst>
                <a:ext uri="{FF2B5EF4-FFF2-40B4-BE49-F238E27FC236}">
                  <a16:creationId xmlns:a16="http://schemas.microsoft.com/office/drawing/2014/main" id="{C9031230-0510-4C0F-8E91-D1E8C788F91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11367460"/>
                </p:ext>
              </p:extLst>
            </p:nvPr>
          </p:nvGraphicFramePr>
          <p:xfrm>
            <a:off x="5207866" y="2386006"/>
            <a:ext cx="2395538" cy="1712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6" name="Prism 10" r:id="rId5" imgW="3857054" imgH="2758060" progId="Prism10.Document">
                    <p:embed/>
                  </p:oleObj>
                </mc:Choice>
                <mc:Fallback>
                  <p:oleObj name="Prism 10" r:id="rId5" imgW="3857054" imgH="2758060" progId="Prism10.Document">
                    <p:embed/>
                    <p:pic>
                      <p:nvPicPr>
                        <p:cNvPr id="3" name="개체 2">
                          <a:extLst>
                            <a:ext uri="{FF2B5EF4-FFF2-40B4-BE49-F238E27FC236}">
                              <a16:creationId xmlns:a16="http://schemas.microsoft.com/office/drawing/2014/main" id="{C9031230-0510-4C0F-8E91-D1E8C788F91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207866" y="2386006"/>
                          <a:ext cx="2395538" cy="17129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개체 3">
              <a:extLst>
                <a:ext uri="{FF2B5EF4-FFF2-40B4-BE49-F238E27FC236}">
                  <a16:creationId xmlns:a16="http://schemas.microsoft.com/office/drawing/2014/main" id="{BCEAF508-E25B-4711-BE63-9B8EE949A80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47679527"/>
                </p:ext>
              </p:extLst>
            </p:nvPr>
          </p:nvGraphicFramePr>
          <p:xfrm>
            <a:off x="7555779" y="2403468"/>
            <a:ext cx="3195637" cy="1692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7" name="Prism 10" r:id="rId7" imgW="5148500" imgH="2727447" progId="Prism10.Document">
                    <p:embed/>
                  </p:oleObj>
                </mc:Choice>
                <mc:Fallback>
                  <p:oleObj name="Prism 10" r:id="rId7" imgW="5148500" imgH="2727447" progId="Prism10.Document">
                    <p:embed/>
                    <p:pic>
                      <p:nvPicPr>
                        <p:cNvPr id="4" name="개체 3">
                          <a:extLst>
                            <a:ext uri="{FF2B5EF4-FFF2-40B4-BE49-F238E27FC236}">
                              <a16:creationId xmlns:a16="http://schemas.microsoft.com/office/drawing/2014/main" id="{BCEAF508-E25B-4711-BE63-9B8EE949A80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555779" y="2403468"/>
                          <a:ext cx="3195637" cy="1692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" name="TextBox 229">
            <a:extLst>
              <a:ext uri="{FF2B5EF4-FFF2-40B4-BE49-F238E27FC236}">
                <a16:creationId xmlns:a16="http://schemas.microsoft.com/office/drawing/2014/main" id="{07567A7D-0505-4242-B196-6AC82AC653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26051" y="2283843"/>
            <a:ext cx="32893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latinLnBrk="0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kumimoji="0" lang="en-US" altLang="ko-KR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0" lang="ko-KR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229">
            <a:extLst>
              <a:ext uri="{FF2B5EF4-FFF2-40B4-BE49-F238E27FC236}">
                <a16:creationId xmlns:a16="http://schemas.microsoft.com/office/drawing/2014/main" id="{2D40EC74-BA9E-4DCF-9F45-7466F4BAA9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7807" y="2339767"/>
            <a:ext cx="3209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latinLnBrk="0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kumimoji="0" lang="en-US" altLang="ko-KR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0" lang="ko-KR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229">
            <a:extLst>
              <a:ext uri="{FF2B5EF4-FFF2-40B4-BE49-F238E27FC236}">
                <a16:creationId xmlns:a16="http://schemas.microsoft.com/office/drawing/2014/main" id="{1319FA6C-D5F1-4E78-85F9-DB23013347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31203" y="2339767"/>
            <a:ext cx="3209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latinLnBrk="0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0" lang="ko-KR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7B5A8F-7535-4276-BE9C-A55FD8A049BA}"/>
              </a:ext>
            </a:extLst>
          </p:cNvPr>
          <p:cNvSpPr txBox="1"/>
          <p:nvPr/>
        </p:nvSpPr>
        <p:spPr>
          <a:xfrm>
            <a:off x="0" y="-3764"/>
            <a:ext cx="9058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Scoring of body weight change, stool consistency and rectal bleeding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7">
            <a:extLst>
              <a:ext uri="{FF2B5EF4-FFF2-40B4-BE49-F238E27FC236}">
                <a16:creationId xmlns:a16="http://schemas.microsoft.com/office/drawing/2014/main" id="{20F16446-B216-4D37-82BE-B6C0F22AB5A1}"/>
              </a:ext>
            </a:extLst>
          </p:cNvPr>
          <p:cNvSpPr txBox="1"/>
          <p:nvPr/>
        </p:nvSpPr>
        <p:spPr>
          <a:xfrm>
            <a:off x="1667508" y="4768872"/>
            <a:ext cx="885698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ko-KR" sz="1400" b="1" dirty="0"/>
              <a:t>Supplementary Figure S1. </a:t>
            </a:r>
            <a:r>
              <a:rPr lang="en-US" altLang="ko-KR" sz="1400" dirty="0"/>
              <a:t>Scoring of body weight change, stool consistency, and rectal bleeding. Colitis was induced in WT and VDUP1 KO mice </a:t>
            </a:r>
            <a:r>
              <a:rPr lang="en-US" altLang="ko-KR" sz="1400"/>
              <a:t>by administering </a:t>
            </a:r>
            <a:r>
              <a:rPr lang="en-US" altLang="ko-KR" sz="1400" dirty="0"/>
              <a:t>2% DSS in the drinking water for 5 days followed by regular drinking water for an additional 4 days. Mice were evaluated daily for (A) body weight loss score, (B) stool consistency score, and (C)rectal bleeding score using indicated criteria (Supplementary Table S1) (n=9). </a:t>
            </a:r>
            <a:r>
              <a:rPr lang="zh-CN" altLang="ko-KR" sz="1400" baseline="30000" dirty="0"/>
              <a:t>§</a:t>
            </a:r>
            <a:r>
              <a:rPr lang="zh-CN" altLang="ko-KR" sz="1400" i="1" dirty="0"/>
              <a:t> </a:t>
            </a:r>
            <a:r>
              <a:rPr lang="en-US" altLang="ko-KR" sz="1400" i="1" dirty="0"/>
              <a:t>P</a:t>
            </a:r>
            <a:r>
              <a:rPr lang="en-US" altLang="ko-KR" sz="1400" dirty="0"/>
              <a:t> &lt;0.05, </a:t>
            </a:r>
            <a:r>
              <a:rPr lang="zh-CN" altLang="ko-KR" sz="1400" baseline="30000" dirty="0"/>
              <a:t>§§</a:t>
            </a:r>
            <a:r>
              <a:rPr lang="zh-CN" altLang="ko-KR" sz="1400" i="1" dirty="0"/>
              <a:t> </a:t>
            </a:r>
            <a:r>
              <a:rPr lang="en-US" altLang="ko-KR" sz="1400" i="1" dirty="0"/>
              <a:t>P</a:t>
            </a:r>
            <a:r>
              <a:rPr lang="en-US" altLang="ko-KR" sz="1400" dirty="0"/>
              <a:t> &lt;0.01,</a:t>
            </a:r>
            <a:r>
              <a:rPr lang="en-US" altLang="ko-KR" sz="1400" baseline="30000" dirty="0"/>
              <a:t> </a:t>
            </a:r>
            <a:r>
              <a:rPr lang="en-US" altLang="ko-KR" sz="1400" dirty="0"/>
              <a:t>for WT 2% DSS vs. VDUP1 KO 2% DSS, *</a:t>
            </a:r>
            <a:r>
              <a:rPr lang="en-US" altLang="ko-KR" sz="1400" i="1" dirty="0"/>
              <a:t> P</a:t>
            </a:r>
            <a:r>
              <a:rPr lang="en-US" altLang="ko-KR" sz="1400" dirty="0"/>
              <a:t> &lt;0.05, **</a:t>
            </a:r>
            <a:r>
              <a:rPr lang="en-US" altLang="ko-KR" sz="1400" i="1" dirty="0"/>
              <a:t> P</a:t>
            </a:r>
            <a:r>
              <a:rPr lang="en-US" altLang="ko-KR" sz="1400" dirty="0"/>
              <a:t> &lt;0.01, ***</a:t>
            </a:r>
            <a:r>
              <a:rPr lang="en-US" altLang="ko-KR" sz="1400" i="1" dirty="0"/>
              <a:t> P</a:t>
            </a:r>
            <a:r>
              <a:rPr lang="en-US" altLang="ko-KR" sz="1400" dirty="0"/>
              <a:t> &lt;0.001, ****</a:t>
            </a:r>
            <a:r>
              <a:rPr lang="en-US" altLang="ko-KR" sz="1400" i="1" dirty="0"/>
              <a:t> P</a:t>
            </a:r>
            <a:r>
              <a:rPr lang="en-US" altLang="ko-KR" sz="1400" dirty="0"/>
              <a:t> &lt;0.0001 for control vs. 2% DSS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2087437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>
            <a:extLst>
              <a:ext uri="{FF2B5EF4-FFF2-40B4-BE49-F238E27FC236}">
                <a16:creationId xmlns:a16="http://schemas.microsoft.com/office/drawing/2014/main" id="{3D8D2A43-89D8-475C-919D-490749AC31C5}"/>
              </a:ext>
            </a:extLst>
          </p:cNvPr>
          <p:cNvGrpSpPr/>
          <p:nvPr/>
        </p:nvGrpSpPr>
        <p:grpSpPr>
          <a:xfrm>
            <a:off x="2006779" y="2612231"/>
            <a:ext cx="8178442" cy="1633538"/>
            <a:chOff x="2075818" y="2259645"/>
            <a:chExt cx="8178442" cy="1633538"/>
          </a:xfrm>
        </p:grpSpPr>
        <p:graphicFrame>
          <p:nvGraphicFramePr>
            <p:cNvPr id="2" name="개체 1">
              <a:extLst>
                <a:ext uri="{FF2B5EF4-FFF2-40B4-BE49-F238E27FC236}">
                  <a16:creationId xmlns:a16="http://schemas.microsoft.com/office/drawing/2014/main" id="{B9BAFB56-E399-432E-80D3-56855638F3E9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4660088" y="2318383"/>
            <a:ext cx="2278063" cy="1574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16" name="Prism 9" r:id="rId3" imgW="3667982" imgH="2536925" progId="Prism9.Document">
                    <p:embed/>
                  </p:oleObj>
                </mc:Choice>
                <mc:Fallback>
                  <p:oleObj name="Prism 9" r:id="rId3" imgW="3667982" imgH="2536925" progId="Prism9.Document">
                    <p:embed/>
                    <p:pic>
                      <p:nvPicPr>
                        <p:cNvPr id="2" name="개체 1">
                          <a:extLst>
                            <a:ext uri="{FF2B5EF4-FFF2-40B4-BE49-F238E27FC236}">
                              <a16:creationId xmlns:a16="http://schemas.microsoft.com/office/drawing/2014/main" id="{B9BAFB56-E399-432E-80D3-56855638F3E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660088" y="2318383"/>
                          <a:ext cx="2278063" cy="1574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개체 2">
              <a:extLst>
                <a:ext uri="{FF2B5EF4-FFF2-40B4-BE49-F238E27FC236}">
                  <a16:creationId xmlns:a16="http://schemas.microsoft.com/office/drawing/2014/main" id="{2C466CEC-BFFD-4B0F-BFF3-99C76CA8EE9A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075818" y="2312033"/>
            <a:ext cx="2278062" cy="158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17" name="Prism 9" r:id="rId5" imgW="3667982" imgH="2546289" progId="Prism9.Document">
                    <p:embed/>
                  </p:oleObj>
                </mc:Choice>
                <mc:Fallback>
                  <p:oleObj name="Prism 9" r:id="rId5" imgW="3667982" imgH="2546289" progId="Prism9.Document">
                    <p:embed/>
                    <p:pic>
                      <p:nvPicPr>
                        <p:cNvPr id="3" name="개체 2">
                          <a:extLst>
                            <a:ext uri="{FF2B5EF4-FFF2-40B4-BE49-F238E27FC236}">
                              <a16:creationId xmlns:a16="http://schemas.microsoft.com/office/drawing/2014/main" id="{2C466CEC-BFFD-4B0F-BFF3-99C76CA8EE9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075818" y="2312033"/>
                          <a:ext cx="2278062" cy="158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개체 3">
              <a:extLst>
                <a:ext uri="{FF2B5EF4-FFF2-40B4-BE49-F238E27FC236}">
                  <a16:creationId xmlns:a16="http://schemas.microsoft.com/office/drawing/2014/main" id="{2A5F37FF-8909-4EE8-803E-EBBBDF9F8B6C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7244360" y="2259645"/>
            <a:ext cx="3009900" cy="16335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18" name="Prism 9" r:id="rId7" imgW="4848147" imgH="2630205" progId="Prism9.Document">
                    <p:embed/>
                  </p:oleObj>
                </mc:Choice>
                <mc:Fallback>
                  <p:oleObj name="Prism 9" r:id="rId7" imgW="4848147" imgH="2630205" progId="Prism9.Document">
                    <p:embed/>
                    <p:pic>
                      <p:nvPicPr>
                        <p:cNvPr id="4" name="개체 3">
                          <a:extLst>
                            <a:ext uri="{FF2B5EF4-FFF2-40B4-BE49-F238E27FC236}">
                              <a16:creationId xmlns:a16="http://schemas.microsoft.com/office/drawing/2014/main" id="{2A5F37FF-8909-4EE8-803E-EBBBDF9F8B6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244360" y="2259645"/>
                          <a:ext cx="3009900" cy="16335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" name="TextBox 229">
            <a:extLst>
              <a:ext uri="{FF2B5EF4-FFF2-40B4-BE49-F238E27FC236}">
                <a16:creationId xmlns:a16="http://schemas.microsoft.com/office/drawing/2014/main" id="{7939D741-CA50-472C-9A58-B02130029C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56901" y="2390000"/>
            <a:ext cx="32893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latinLnBrk="0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kumimoji="0" lang="en-US" altLang="ko-KR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0" lang="ko-KR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229">
            <a:extLst>
              <a:ext uri="{FF2B5EF4-FFF2-40B4-BE49-F238E27FC236}">
                <a16:creationId xmlns:a16="http://schemas.microsoft.com/office/drawing/2014/main" id="{12D50A6C-2927-491F-8400-C702D57D2B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70127" y="2390000"/>
            <a:ext cx="3209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latinLnBrk="0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kumimoji="0" lang="en-US" altLang="ko-KR" sz="16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0" lang="ko-KR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229">
            <a:extLst>
              <a:ext uri="{FF2B5EF4-FFF2-40B4-BE49-F238E27FC236}">
                <a16:creationId xmlns:a16="http://schemas.microsoft.com/office/drawing/2014/main" id="{38ED7871-348D-4221-9018-F088BA9CAD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69112" y="2390000"/>
            <a:ext cx="3209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latinLnBrk="0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0" lang="ko-KR" altLang="en-US" sz="16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060532-E712-4618-BCF0-F60551715BDB}"/>
              </a:ext>
            </a:extLst>
          </p:cNvPr>
          <p:cNvSpPr txBox="1"/>
          <p:nvPr/>
        </p:nvSpPr>
        <p:spPr>
          <a:xfrm>
            <a:off x="0" y="-3764"/>
            <a:ext cx="8344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Scoring of inflammation, epithelial defects, and crypt atrophy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7">
            <a:extLst>
              <a:ext uri="{FF2B5EF4-FFF2-40B4-BE49-F238E27FC236}">
                <a16:creationId xmlns:a16="http://schemas.microsoft.com/office/drawing/2014/main" id="{05C16060-B1CA-4AB7-AD87-B540AF4975E4}"/>
              </a:ext>
            </a:extLst>
          </p:cNvPr>
          <p:cNvSpPr txBox="1"/>
          <p:nvPr/>
        </p:nvSpPr>
        <p:spPr>
          <a:xfrm>
            <a:off x="1667508" y="4768872"/>
            <a:ext cx="885698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ko-KR" sz="1400" b="1" dirty="0"/>
              <a:t>Supplementary Figure S2. </a:t>
            </a:r>
            <a:r>
              <a:rPr lang="en-US" altLang="ko-KR" sz="1400" dirty="0"/>
              <a:t>VDUP1-deficiency enhances histological scores, including inflammation, epithelial defects, and crypt atrophy were analyzed. H&amp;E sections were blindly scored according to the inflammation score, epithelial defects score, and crypt atrophy score, according to the indicated criteria (Supplementary Table S2). ***</a:t>
            </a:r>
            <a:r>
              <a:rPr lang="en-US" altLang="ko-KR" sz="1400" i="1" dirty="0"/>
              <a:t> P</a:t>
            </a:r>
            <a:r>
              <a:rPr lang="en-US" altLang="ko-KR" sz="1400" dirty="0"/>
              <a:t> &lt;0.001, ****</a:t>
            </a:r>
            <a:r>
              <a:rPr lang="en-US" altLang="ko-KR" sz="1400" i="1" dirty="0"/>
              <a:t> P</a:t>
            </a:r>
            <a:r>
              <a:rPr lang="en-US" altLang="ko-KR" sz="1400" dirty="0"/>
              <a:t> &lt;0.0001, ns, not significant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186412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7FD1A174-7CF4-40FF-9606-B5705100ACF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525"/>
          <a:stretch/>
        </p:blipFill>
        <p:spPr>
          <a:xfrm>
            <a:off x="4052104" y="2187352"/>
            <a:ext cx="3127621" cy="212320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A41155C-F927-48F2-822C-97ABDA347EDA}"/>
              </a:ext>
            </a:extLst>
          </p:cNvPr>
          <p:cNvSpPr txBox="1"/>
          <p:nvPr/>
        </p:nvSpPr>
        <p:spPr>
          <a:xfrm>
            <a:off x="4459448" y="2854804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4%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1CEEA54-38BC-48CA-BFCD-BCEF1E6536B0}"/>
              </a:ext>
            </a:extLst>
          </p:cNvPr>
          <p:cNvSpPr txBox="1"/>
          <p:nvPr/>
        </p:nvSpPr>
        <p:spPr>
          <a:xfrm>
            <a:off x="4844192" y="2524961"/>
            <a:ext cx="377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%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0BE33D5-8AE5-47E1-A60F-238B5EEE492F}"/>
              </a:ext>
            </a:extLst>
          </p:cNvPr>
          <p:cNvSpPr txBox="1"/>
          <p:nvPr/>
        </p:nvSpPr>
        <p:spPr>
          <a:xfrm>
            <a:off x="5580746" y="2713011"/>
            <a:ext cx="4443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8%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1B9C1E2-F4BF-4253-89FA-A8053E26E939}"/>
              </a:ext>
            </a:extLst>
          </p:cNvPr>
          <p:cNvSpPr txBox="1"/>
          <p:nvPr/>
        </p:nvSpPr>
        <p:spPr>
          <a:xfrm>
            <a:off x="5669382" y="2428226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8.3%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A609FD3-BD35-4D0E-A620-2479FB0A1B54}"/>
              </a:ext>
            </a:extLst>
          </p:cNvPr>
          <p:cNvSpPr txBox="1"/>
          <p:nvPr/>
        </p:nvSpPr>
        <p:spPr>
          <a:xfrm>
            <a:off x="4844192" y="4281617"/>
            <a:ext cx="1210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4/80 positive cells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27F65E39-4E6E-444A-9948-18986D1952E9}"/>
              </a:ext>
            </a:extLst>
          </p:cNvPr>
          <p:cNvSpPr/>
          <p:nvPr/>
        </p:nvSpPr>
        <p:spPr>
          <a:xfrm>
            <a:off x="6753460" y="2595236"/>
            <a:ext cx="144016" cy="78041"/>
          </a:xfrm>
          <a:prstGeom prst="rect">
            <a:avLst/>
          </a:prstGeom>
          <a:solidFill>
            <a:srgbClr val="FF0000">
              <a:alpha val="50000"/>
            </a:srgbClr>
          </a:solidFill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C895CD50-6D4D-46FC-BDBD-335EE5390FCD}"/>
              </a:ext>
            </a:extLst>
          </p:cNvPr>
          <p:cNvSpPr/>
          <p:nvPr/>
        </p:nvSpPr>
        <p:spPr>
          <a:xfrm>
            <a:off x="6753460" y="2740036"/>
            <a:ext cx="144016" cy="78041"/>
          </a:xfrm>
          <a:prstGeom prst="rect">
            <a:avLst/>
          </a:prstGeom>
          <a:solidFill>
            <a:srgbClr val="0070C0">
              <a:alpha val="50000"/>
            </a:srgbClr>
          </a:solidFill>
          <a:ln w="190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2E339AD7-E0A3-4F81-A136-38A26C76EFFC}"/>
              </a:ext>
            </a:extLst>
          </p:cNvPr>
          <p:cNvSpPr/>
          <p:nvPr/>
        </p:nvSpPr>
        <p:spPr>
          <a:xfrm>
            <a:off x="6753460" y="2884836"/>
            <a:ext cx="144016" cy="78041"/>
          </a:xfrm>
          <a:prstGeom prst="rect">
            <a:avLst/>
          </a:prstGeom>
          <a:solidFill>
            <a:schemeClr val="accent6">
              <a:alpha val="50000"/>
            </a:schemeClr>
          </a:solidFill>
          <a:ln w="1905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24AC5C70-5A68-4B7F-94C8-1B3410C757DA}"/>
              </a:ext>
            </a:extLst>
          </p:cNvPr>
          <p:cNvSpPr/>
          <p:nvPr/>
        </p:nvSpPr>
        <p:spPr>
          <a:xfrm>
            <a:off x="6753460" y="3039366"/>
            <a:ext cx="144016" cy="78041"/>
          </a:xfrm>
          <a:prstGeom prst="rect">
            <a:avLst/>
          </a:prstGeom>
          <a:solidFill>
            <a:schemeClr val="accent3">
              <a:alpha val="50000"/>
            </a:schemeClr>
          </a:solidFill>
          <a:ln w="190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4FD89C3-9F7F-4299-BD5D-A1A9C0B95640}"/>
              </a:ext>
            </a:extLst>
          </p:cNvPr>
          <p:cNvSpPr txBox="1"/>
          <p:nvPr/>
        </p:nvSpPr>
        <p:spPr>
          <a:xfrm>
            <a:off x="6868900" y="2511145"/>
            <a:ext cx="12394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isotype control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7CDED1-578E-468E-92B7-42E52E1BCD82}"/>
              </a:ext>
            </a:extLst>
          </p:cNvPr>
          <p:cNvSpPr txBox="1"/>
          <p:nvPr/>
        </p:nvSpPr>
        <p:spPr>
          <a:xfrm>
            <a:off x="6868900" y="2659189"/>
            <a:ext cx="16786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DUP1 KO isotype control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102BE92-0432-4053-BA81-3F61C1CDD0DA}"/>
              </a:ext>
            </a:extLst>
          </p:cNvPr>
          <p:cNvSpPr txBox="1"/>
          <p:nvPr/>
        </p:nvSpPr>
        <p:spPr>
          <a:xfrm>
            <a:off x="6868900" y="2807233"/>
            <a:ext cx="1188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F4/80 positive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4CFA850-D1A9-4DD6-A57A-9C62E941DF8E}"/>
              </a:ext>
            </a:extLst>
          </p:cNvPr>
          <p:cNvSpPr txBox="1"/>
          <p:nvPr/>
        </p:nvSpPr>
        <p:spPr>
          <a:xfrm>
            <a:off x="6868900" y="2955276"/>
            <a:ext cx="16273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DUP1 KO F4/80 positive</a:t>
            </a:r>
            <a:endParaRPr lang="ko-KR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55419AA-21CA-4BB6-A00B-D5F00B3783CC}"/>
              </a:ext>
            </a:extLst>
          </p:cNvPr>
          <p:cNvSpPr txBox="1"/>
          <p:nvPr/>
        </p:nvSpPr>
        <p:spPr>
          <a:xfrm>
            <a:off x="0" y="-3764"/>
            <a:ext cx="8157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Differentiation of BMDMs from VDUP1 KO and WT mice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7">
            <a:extLst>
              <a:ext uri="{FF2B5EF4-FFF2-40B4-BE49-F238E27FC236}">
                <a16:creationId xmlns:a16="http://schemas.microsoft.com/office/drawing/2014/main" id="{D1646405-44B0-4C7F-8257-E10A6F93EB42}"/>
              </a:ext>
            </a:extLst>
          </p:cNvPr>
          <p:cNvSpPr txBox="1"/>
          <p:nvPr/>
        </p:nvSpPr>
        <p:spPr>
          <a:xfrm>
            <a:off x="1667508" y="4768872"/>
            <a:ext cx="885698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ko-KR" sz="1400" b="1" dirty="0"/>
              <a:t>Supplementary Figure S3. </a:t>
            </a:r>
            <a:r>
              <a:rPr lang="en-US" altLang="ko-KR" sz="1400" dirty="0"/>
              <a:t>Differentiation of BMDMs from WT and VDUP1 KO mice. BMDMs were generated by treating BM cells obtained from male VDUP1 KO mice and WT mice with macrophage colony-stimulating factor (MCSF). Cells were labeled with F4/80 antibody and isotype control. The differentiation rate of BMDMs was determined using flow cytometry. 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23792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2</TotalTime>
  <Words>342</Words>
  <Application>Microsoft Office PowerPoint</Application>
  <PresentationFormat>와이드스크린</PresentationFormat>
  <Paragraphs>21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3</vt:i4>
      </vt:variant>
    </vt:vector>
  </HeadingPairs>
  <TitlesOfParts>
    <vt:vector size="10" baseType="lpstr">
      <vt:lpstr>等线</vt:lpstr>
      <vt:lpstr>맑은 고딕</vt:lpstr>
      <vt:lpstr>Arial</vt:lpstr>
      <vt:lpstr>Times New Roman</vt:lpstr>
      <vt:lpstr>Office 테마</vt:lpstr>
      <vt:lpstr>Prism 10</vt:lpstr>
      <vt:lpstr>Prism 9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2</cp:revision>
  <cp:lastPrinted>2023-07-06T23:55:25Z</cp:lastPrinted>
  <dcterms:created xsi:type="dcterms:W3CDTF">2023-07-05T05:57:15Z</dcterms:created>
  <dcterms:modified xsi:type="dcterms:W3CDTF">2023-09-01T04:30:06Z</dcterms:modified>
</cp:coreProperties>
</file>